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8999538" cy="7199313"/>
  <p:notesSz cx="6858000" cy="9144000"/>
  <p:defaultTextStyle>
    <a:defPPr>
      <a:defRPr lang="en-US"/>
    </a:defPPr>
    <a:lvl1pPr marL="0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1pPr>
    <a:lvl2pPr marL="841450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2pPr>
    <a:lvl3pPr marL="1682900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3pPr>
    <a:lvl4pPr marL="2524347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4pPr>
    <a:lvl5pPr marL="3365801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5pPr>
    <a:lvl6pPr marL="4207252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6pPr>
    <a:lvl7pPr marL="5048701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7pPr>
    <a:lvl8pPr marL="5890149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8pPr>
    <a:lvl9pPr marL="6731599" algn="l" defTabSz="1682900" rtl="0" eaLnBrk="1" latinLnBrk="0" hangingPunct="1">
      <a:defRPr sz="33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68" userDrawn="1">
          <p15:clr>
            <a:srgbClr val="A4A3A4"/>
          </p15:clr>
        </p15:guide>
        <p15:guide id="2" pos="28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F948ABD-CA5B-423D-AD7E-FA215162375B}" v="5" dt="2021-12-16T07:23:18.79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788" y="210"/>
      </p:cViewPr>
      <p:guideLst>
        <p:guide orient="horz" pos="2268"/>
        <p:guide pos="28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u Wei-Xin" userId="355868643b3debea" providerId="LiveId" clId="{3F948ABD-CA5B-423D-AD7E-FA215162375B}"/>
    <pc:docChg chg="undo custSel modSld modMainMaster modNotesMaster">
      <pc:chgData name="Liu Wei-Xin" userId="355868643b3debea" providerId="LiveId" clId="{3F948ABD-CA5B-423D-AD7E-FA215162375B}" dt="2021-12-16T09:00:04.303" v="25" actId="732"/>
      <pc:docMkLst>
        <pc:docMk/>
      </pc:docMkLst>
      <pc:sldChg chg="addSp delSp modSp mod modNotes">
        <pc:chgData name="Liu Wei-Xin" userId="355868643b3debea" providerId="LiveId" clId="{3F948ABD-CA5B-423D-AD7E-FA215162375B}" dt="2021-12-16T09:00:04.303" v="25" actId="732"/>
        <pc:sldMkLst>
          <pc:docMk/>
          <pc:sldMk cId="594491241" sldId="257"/>
        </pc:sldMkLst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8" creationId="{7FBAA2CA-2A6D-4558-88B4-CBC898C41BA7}"/>
          </ac:spMkLst>
        </pc:spChg>
        <pc:spChg chg="del">
          <ac:chgData name="Liu Wei-Xin" userId="355868643b3debea" providerId="LiveId" clId="{3F948ABD-CA5B-423D-AD7E-FA215162375B}" dt="2021-12-16T07:22:30.793" v="0" actId="478"/>
          <ac:spMkLst>
            <pc:docMk/>
            <pc:sldMk cId="594491241" sldId="257"/>
            <ac:spMk id="28" creationId="{CF17A099-66B7-4B78-BBD0-F0DC658EDC91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29" creationId="{7DF68198-76E7-4018-B093-E8F48EB1BC73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30" creationId="{C2392D1B-28CA-4947-B971-D50E8FBD05C3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31" creationId="{87AECD9F-0A20-43F0-9612-4AEEA3684AA5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34" creationId="{7BEAEB25-D60C-4590-80D4-8B2A1C539518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35" creationId="{C340A50C-8DEF-4E35-A1FA-70AE9FBF1740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36" creationId="{BE8EE027-7BE6-4ED0-A2E3-DE69C72295CB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38" creationId="{C849896D-A0C4-4439-8614-7405C0E95285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41" creationId="{175E980B-1D90-491C-A07C-AAB079EB2CF1}"/>
          </ac:spMkLst>
        </pc:spChg>
        <pc:spChg chg="mod topLvl">
          <ac:chgData name="Liu Wei-Xin" userId="355868643b3debea" providerId="LiveId" clId="{3F948ABD-CA5B-423D-AD7E-FA215162375B}" dt="2021-12-16T07:23:30.233" v="10" actId="1076"/>
          <ac:spMkLst>
            <pc:docMk/>
            <pc:sldMk cId="594491241" sldId="257"/>
            <ac:spMk id="42" creationId="{B1F7AD3C-7B4D-4F1C-BF82-76775AFF34D6}"/>
          </ac:spMkLst>
        </pc:spChg>
        <pc:grpChg chg="add del mod">
          <ac:chgData name="Liu Wei-Xin" userId="355868643b3debea" providerId="LiveId" clId="{3F948ABD-CA5B-423D-AD7E-FA215162375B}" dt="2021-12-16T07:23:18.794" v="8" actId="165"/>
          <ac:grpSpMkLst>
            <pc:docMk/>
            <pc:sldMk cId="594491241" sldId="257"/>
            <ac:grpSpMk id="2" creationId="{92B58888-2503-4A51-81FF-CF7156CE84ED}"/>
          </ac:grpSpMkLst>
        </pc:grpChg>
        <pc:picChg chg="mod topLvl modCrop">
          <ac:chgData name="Liu Wei-Xin" userId="355868643b3debea" providerId="LiveId" clId="{3F948ABD-CA5B-423D-AD7E-FA215162375B}" dt="2021-12-16T08:59:13.519" v="17" actId="732"/>
          <ac:picMkLst>
            <pc:docMk/>
            <pc:sldMk cId="594491241" sldId="257"/>
            <ac:picMk id="19" creationId="{9CA385BB-0C90-4F79-A77B-141D08CC0DA0}"/>
          </ac:picMkLst>
        </pc:picChg>
        <pc:picChg chg="mod topLvl modCrop">
          <ac:chgData name="Liu Wei-Xin" userId="355868643b3debea" providerId="LiveId" clId="{3F948ABD-CA5B-423D-AD7E-FA215162375B}" dt="2021-12-16T08:59:41.983" v="21" actId="18131"/>
          <ac:picMkLst>
            <pc:docMk/>
            <pc:sldMk cId="594491241" sldId="257"/>
            <ac:picMk id="20" creationId="{CB8BA292-D6DD-4E4E-AE89-08A3EB02CA10}"/>
          </ac:picMkLst>
        </pc:picChg>
        <pc:picChg chg="mod topLvl modCrop">
          <ac:chgData name="Liu Wei-Xin" userId="355868643b3debea" providerId="LiveId" clId="{3F948ABD-CA5B-423D-AD7E-FA215162375B}" dt="2021-12-16T08:59:29.343" v="19" actId="1076"/>
          <ac:picMkLst>
            <pc:docMk/>
            <pc:sldMk cId="594491241" sldId="257"/>
            <ac:picMk id="32" creationId="{A8E4C5ED-FAEF-4EB3-A847-E528C48DB791}"/>
          </ac:picMkLst>
        </pc:picChg>
        <pc:picChg chg="mod topLvl modCrop">
          <ac:chgData name="Liu Wei-Xin" userId="355868643b3debea" providerId="LiveId" clId="{3F948ABD-CA5B-423D-AD7E-FA215162375B}" dt="2021-12-16T09:00:04.303" v="25" actId="732"/>
          <ac:picMkLst>
            <pc:docMk/>
            <pc:sldMk cId="594491241" sldId="257"/>
            <ac:picMk id="33" creationId="{8CA1FA40-05F4-4855-B526-DE92604B39E5}"/>
          </ac:picMkLst>
        </pc:picChg>
      </pc:sldChg>
      <pc:sldMasterChg chg="modSp modSldLayout">
        <pc:chgData name="Liu Wei-Xin" userId="355868643b3debea" providerId="LiveId" clId="{3F948ABD-CA5B-423D-AD7E-FA215162375B}" dt="2021-12-16T07:22:58.520" v="5"/>
        <pc:sldMasterMkLst>
          <pc:docMk/>
          <pc:sldMasterMk cId="4024762935" sldId="2147483648"/>
        </pc:sldMasterMkLst>
        <pc:spChg chg="mod">
          <ac:chgData name="Liu Wei-Xin" userId="355868643b3debea" providerId="LiveId" clId="{3F948ABD-CA5B-423D-AD7E-FA215162375B}" dt="2021-12-16T07:22:58.520" v="5"/>
          <ac:spMkLst>
            <pc:docMk/>
            <pc:sldMasterMk cId="4024762935" sldId="2147483648"/>
            <ac:spMk id="2" creationId="{00000000-0000-0000-0000-000000000000}"/>
          </ac:spMkLst>
        </pc:spChg>
        <pc:spChg chg="mod">
          <ac:chgData name="Liu Wei-Xin" userId="355868643b3debea" providerId="LiveId" clId="{3F948ABD-CA5B-423D-AD7E-FA215162375B}" dt="2021-12-16T07:22:58.520" v="5"/>
          <ac:spMkLst>
            <pc:docMk/>
            <pc:sldMasterMk cId="4024762935" sldId="2147483648"/>
            <ac:spMk id="3" creationId="{00000000-0000-0000-0000-000000000000}"/>
          </ac:spMkLst>
        </pc:spChg>
        <pc:spChg chg="mod">
          <ac:chgData name="Liu Wei-Xin" userId="355868643b3debea" providerId="LiveId" clId="{3F948ABD-CA5B-423D-AD7E-FA215162375B}" dt="2021-12-16T07:22:58.520" v="5"/>
          <ac:spMkLst>
            <pc:docMk/>
            <pc:sldMasterMk cId="4024762935" sldId="2147483648"/>
            <ac:spMk id="4" creationId="{00000000-0000-0000-0000-000000000000}"/>
          </ac:spMkLst>
        </pc:spChg>
        <pc:spChg chg="mod">
          <ac:chgData name="Liu Wei-Xin" userId="355868643b3debea" providerId="LiveId" clId="{3F948ABD-CA5B-423D-AD7E-FA215162375B}" dt="2021-12-16T07:22:58.520" v="5"/>
          <ac:spMkLst>
            <pc:docMk/>
            <pc:sldMasterMk cId="4024762935" sldId="2147483648"/>
            <ac:spMk id="5" creationId="{00000000-0000-0000-0000-000000000000}"/>
          </ac:spMkLst>
        </pc:spChg>
        <pc:spChg chg="mod">
          <ac:chgData name="Liu Wei-Xin" userId="355868643b3debea" providerId="LiveId" clId="{3F948ABD-CA5B-423D-AD7E-FA215162375B}" dt="2021-12-16T07:22:58.520" v="5"/>
          <ac:spMkLst>
            <pc:docMk/>
            <pc:sldMasterMk cId="4024762935" sldId="2147483648"/>
            <ac:spMk id="6" creationId="{00000000-0000-0000-0000-000000000000}"/>
          </ac:spMkLst>
        </pc:spChg>
        <pc:sldLayoutChg chg="modSp">
          <pc:chgData name="Liu Wei-Xin" userId="355868643b3debea" providerId="LiveId" clId="{3F948ABD-CA5B-423D-AD7E-FA215162375B}" dt="2021-12-16T07:22:58.520" v="5"/>
          <pc:sldLayoutMkLst>
            <pc:docMk/>
            <pc:sldMasterMk cId="4024762935" sldId="2147483648"/>
            <pc:sldLayoutMk cId="2354780366" sldId="2147483649"/>
          </pc:sldLayoutMkLst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2354780366" sldId="2147483649"/>
              <ac:spMk id="2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2354780366" sldId="2147483649"/>
              <ac:spMk id="3" creationId="{00000000-0000-0000-0000-000000000000}"/>
            </ac:spMkLst>
          </pc:spChg>
        </pc:sldLayoutChg>
        <pc:sldLayoutChg chg="modSp">
          <pc:chgData name="Liu Wei-Xin" userId="355868643b3debea" providerId="LiveId" clId="{3F948ABD-CA5B-423D-AD7E-FA215162375B}" dt="2021-12-16T07:22:58.520" v="5"/>
          <pc:sldLayoutMkLst>
            <pc:docMk/>
            <pc:sldMasterMk cId="4024762935" sldId="2147483648"/>
            <pc:sldLayoutMk cId="2720809504" sldId="2147483651"/>
          </pc:sldLayoutMkLst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2720809504" sldId="2147483651"/>
              <ac:spMk id="2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2720809504" sldId="2147483651"/>
              <ac:spMk id="3" creationId="{00000000-0000-0000-0000-000000000000}"/>
            </ac:spMkLst>
          </pc:spChg>
        </pc:sldLayoutChg>
        <pc:sldLayoutChg chg="modSp">
          <pc:chgData name="Liu Wei-Xin" userId="355868643b3debea" providerId="LiveId" clId="{3F948ABD-CA5B-423D-AD7E-FA215162375B}" dt="2021-12-16T07:22:58.520" v="5"/>
          <pc:sldLayoutMkLst>
            <pc:docMk/>
            <pc:sldMasterMk cId="4024762935" sldId="2147483648"/>
            <pc:sldLayoutMk cId="1050180382" sldId="2147483652"/>
          </pc:sldLayoutMkLst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1050180382" sldId="2147483652"/>
              <ac:spMk id="3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1050180382" sldId="2147483652"/>
              <ac:spMk id="4" creationId="{00000000-0000-0000-0000-000000000000}"/>
            </ac:spMkLst>
          </pc:spChg>
        </pc:sldLayoutChg>
        <pc:sldLayoutChg chg="modSp">
          <pc:chgData name="Liu Wei-Xin" userId="355868643b3debea" providerId="LiveId" clId="{3F948ABD-CA5B-423D-AD7E-FA215162375B}" dt="2021-12-16T07:22:58.520" v="5"/>
          <pc:sldLayoutMkLst>
            <pc:docMk/>
            <pc:sldMasterMk cId="4024762935" sldId="2147483648"/>
            <pc:sldLayoutMk cId="1414771998" sldId="2147483653"/>
          </pc:sldLayoutMkLst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1414771998" sldId="2147483653"/>
              <ac:spMk id="3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1414771998" sldId="2147483653"/>
              <ac:spMk id="4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1414771998" sldId="2147483653"/>
              <ac:spMk id="5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1414771998" sldId="2147483653"/>
              <ac:spMk id="6" creationId="{00000000-0000-0000-0000-000000000000}"/>
            </ac:spMkLst>
          </pc:spChg>
        </pc:sldLayoutChg>
        <pc:sldLayoutChg chg="modSp">
          <pc:chgData name="Liu Wei-Xin" userId="355868643b3debea" providerId="LiveId" clId="{3F948ABD-CA5B-423D-AD7E-FA215162375B}" dt="2021-12-16T07:22:58.520" v="5"/>
          <pc:sldLayoutMkLst>
            <pc:docMk/>
            <pc:sldMasterMk cId="4024762935" sldId="2147483648"/>
            <pc:sldLayoutMk cId="3559115127" sldId="2147483656"/>
          </pc:sldLayoutMkLst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3559115127" sldId="2147483656"/>
              <ac:spMk id="2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3559115127" sldId="2147483656"/>
              <ac:spMk id="3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3559115127" sldId="2147483656"/>
              <ac:spMk id="4" creationId="{00000000-0000-0000-0000-000000000000}"/>
            </ac:spMkLst>
          </pc:spChg>
        </pc:sldLayoutChg>
        <pc:sldLayoutChg chg="modSp">
          <pc:chgData name="Liu Wei-Xin" userId="355868643b3debea" providerId="LiveId" clId="{3F948ABD-CA5B-423D-AD7E-FA215162375B}" dt="2021-12-16T07:22:58.520" v="5"/>
          <pc:sldLayoutMkLst>
            <pc:docMk/>
            <pc:sldMasterMk cId="4024762935" sldId="2147483648"/>
            <pc:sldLayoutMk cId="2438420599" sldId="2147483657"/>
          </pc:sldLayoutMkLst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2438420599" sldId="2147483657"/>
              <ac:spMk id="2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2438420599" sldId="2147483657"/>
              <ac:spMk id="3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2438420599" sldId="2147483657"/>
              <ac:spMk id="4" creationId="{00000000-0000-0000-0000-000000000000}"/>
            </ac:spMkLst>
          </pc:spChg>
        </pc:sldLayoutChg>
        <pc:sldLayoutChg chg="modSp">
          <pc:chgData name="Liu Wei-Xin" userId="355868643b3debea" providerId="LiveId" clId="{3F948ABD-CA5B-423D-AD7E-FA215162375B}" dt="2021-12-16T07:22:58.520" v="5"/>
          <pc:sldLayoutMkLst>
            <pc:docMk/>
            <pc:sldMasterMk cId="4024762935" sldId="2147483648"/>
            <pc:sldLayoutMk cId="3750249237" sldId="2147483659"/>
          </pc:sldLayoutMkLst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3750249237" sldId="2147483659"/>
              <ac:spMk id="2" creationId="{00000000-0000-0000-0000-000000000000}"/>
            </ac:spMkLst>
          </pc:spChg>
          <pc:spChg chg="mod">
            <ac:chgData name="Liu Wei-Xin" userId="355868643b3debea" providerId="LiveId" clId="{3F948ABD-CA5B-423D-AD7E-FA215162375B}" dt="2021-12-16T07:22:58.520" v="5"/>
            <ac:spMkLst>
              <pc:docMk/>
              <pc:sldMasterMk cId="4024762935" sldId="2147483648"/>
              <pc:sldLayoutMk cId="3750249237" sldId="2147483659"/>
              <ac:spMk id="3" creationId="{00000000-0000-0000-0000-000000000000}"/>
            </ac:spMkLst>
          </pc:spChg>
        </pc:sldLayoutChg>
      </pc:sldMasterChg>
    </pc:docChg>
  </pc:docChgLst>
  <pc:docChgLst>
    <pc:chgData name="Liu Wei-Xin" userId="355868643b3debea" providerId="LiveId" clId="{F9E222F4-AC18-4181-93BA-B8D3E293BED7}"/>
    <pc:docChg chg="undo custSel modSld">
      <pc:chgData name="Liu Wei-Xin" userId="355868643b3debea" providerId="LiveId" clId="{F9E222F4-AC18-4181-93BA-B8D3E293BED7}" dt="2021-10-21T11:14:49.481" v="65" actId="20577"/>
      <pc:docMkLst>
        <pc:docMk/>
      </pc:docMkLst>
      <pc:sldChg chg="modSp mod">
        <pc:chgData name="Liu Wei-Xin" userId="355868643b3debea" providerId="LiveId" clId="{F9E222F4-AC18-4181-93BA-B8D3E293BED7}" dt="2021-10-21T11:14:49.481" v="65" actId="20577"/>
        <pc:sldMkLst>
          <pc:docMk/>
          <pc:sldMk cId="594491241" sldId="257"/>
        </pc:sldMkLst>
        <pc:spChg chg="mod">
          <ac:chgData name="Liu Wei-Xin" userId="355868643b3debea" providerId="LiveId" clId="{F9E222F4-AC18-4181-93BA-B8D3E293BED7}" dt="2021-10-21T11:14:49.481" v="65" actId="20577"/>
          <ac:spMkLst>
            <pc:docMk/>
            <pc:sldMk cId="594491241" sldId="257"/>
            <ac:spMk id="28" creationId="{CF17A099-66B7-4B78-BBD0-F0DC658EDC91}"/>
          </ac:spMkLst>
        </pc:spChg>
      </pc:sldChg>
    </pc:docChg>
  </pc:docChgLst>
  <pc:docChgLst>
    <pc:chgData name="Liu Wei-Xin" userId="355868643b3debea" providerId="LiveId" clId="{2F3653A7-5210-4F99-A9C4-FAF3E71D44A1}"/>
    <pc:docChg chg="custSel modSld">
      <pc:chgData name="Liu Wei-Xin" userId="355868643b3debea" providerId="LiveId" clId="{2F3653A7-5210-4F99-A9C4-FAF3E71D44A1}" dt="2021-09-28T02:25:09.426" v="170" actId="20577"/>
      <pc:docMkLst>
        <pc:docMk/>
      </pc:docMkLst>
      <pc:sldChg chg="addSp delSp modSp mod">
        <pc:chgData name="Liu Wei-Xin" userId="355868643b3debea" providerId="LiveId" clId="{2F3653A7-5210-4F99-A9C4-FAF3E71D44A1}" dt="2021-09-28T02:25:09.426" v="170" actId="20577"/>
        <pc:sldMkLst>
          <pc:docMk/>
          <pc:sldMk cId="594491241" sldId="257"/>
        </pc:sldMkLst>
        <pc:spChg chg="mod">
          <ac:chgData name="Liu Wei-Xin" userId="355868643b3debea" providerId="LiveId" clId="{2F3653A7-5210-4F99-A9C4-FAF3E71D44A1}" dt="2021-09-28T02:20:38.479" v="155" actId="20577"/>
          <ac:spMkLst>
            <pc:docMk/>
            <pc:sldMk cId="594491241" sldId="257"/>
            <ac:spMk id="9" creationId="{92B0196B-CAD2-4732-A27C-7B32BE95AE92}"/>
          </ac:spMkLst>
        </pc:spChg>
        <pc:spChg chg="mod">
          <ac:chgData name="Liu Wei-Xin" userId="355868643b3debea" providerId="LiveId" clId="{2F3653A7-5210-4F99-A9C4-FAF3E71D44A1}" dt="2021-09-28T02:19:30.312" v="39" actId="20577"/>
          <ac:spMkLst>
            <pc:docMk/>
            <pc:sldMk cId="594491241" sldId="257"/>
            <ac:spMk id="12" creationId="{F02E61AD-4040-441B-9C45-A8A1E31BE943}"/>
          </ac:spMkLst>
        </pc:spChg>
        <pc:graphicFrameChg chg="add del mod">
          <ac:chgData name="Liu Wei-Xin" userId="355868643b3debea" providerId="LiveId" clId="{2F3653A7-5210-4F99-A9C4-FAF3E71D44A1}" dt="2021-09-28T02:18:51.777" v="10"/>
          <ac:graphicFrameMkLst>
            <pc:docMk/>
            <pc:sldMk cId="594491241" sldId="257"/>
            <ac:graphicFrameMk id="2" creationId="{1D85B046-77F1-48D6-9B50-53E842F2307A}"/>
          </ac:graphicFrameMkLst>
        </pc:graphicFrameChg>
        <pc:graphicFrameChg chg="add mod modGraphic">
          <ac:chgData name="Liu Wei-Xin" userId="355868643b3debea" providerId="LiveId" clId="{2F3653A7-5210-4F99-A9C4-FAF3E71D44A1}" dt="2021-09-28T02:25:09.426" v="170" actId="20577"/>
          <ac:graphicFrameMkLst>
            <pc:docMk/>
            <pc:sldMk cId="594491241" sldId="257"/>
            <ac:graphicFrameMk id="3" creationId="{02D514CA-CF19-45B8-9C76-A55E0D3715C4}"/>
          </ac:graphicFrameMkLst>
        </pc:graphicFrameChg>
        <pc:graphicFrameChg chg="del">
          <ac:chgData name="Liu Wei-Xin" userId="355868643b3debea" providerId="LiveId" clId="{2F3653A7-5210-4F99-A9C4-FAF3E71D44A1}" dt="2021-09-28T02:18:23.086" v="0" actId="478"/>
          <ac:graphicFrameMkLst>
            <pc:docMk/>
            <pc:sldMk cId="594491241" sldId="257"/>
            <ac:graphicFrameMk id="10" creationId="{79AF636C-6045-48F5-BDE7-65DC028632D5}"/>
          </ac:graphicFrameMkLst>
        </pc:graphicFrameChg>
      </pc:sldChg>
    </pc:docChg>
  </pc:docChgLst>
  <pc:docChgLst>
    <pc:chgData name="Liu Wei-Xin" userId="355868643b3debea" providerId="LiveId" clId="{2040446B-C38A-46C4-B01C-56E514B30C92}"/>
    <pc:docChg chg="undo redo custSel modSld">
      <pc:chgData name="Liu Wei-Xin" userId="355868643b3debea" providerId="LiveId" clId="{2040446B-C38A-46C4-B01C-56E514B30C92}" dt="2021-09-28T10:56:07.357" v="463" actId="20577"/>
      <pc:docMkLst>
        <pc:docMk/>
      </pc:docMkLst>
      <pc:sldChg chg="addSp delSp modSp mod">
        <pc:chgData name="Liu Wei-Xin" userId="355868643b3debea" providerId="LiveId" clId="{2040446B-C38A-46C4-B01C-56E514B30C92}" dt="2021-09-28T10:56:07.357" v="463" actId="20577"/>
        <pc:sldMkLst>
          <pc:docMk/>
          <pc:sldMk cId="594491241" sldId="257"/>
        </pc:sldMkLst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7" creationId="{91287A24-18DF-4A67-88CE-B8746DB9FB98}"/>
          </ac:spMkLst>
        </pc:spChg>
        <pc:spChg chg="del">
          <ac:chgData name="Liu Wei-Xin" userId="355868643b3debea" providerId="LiveId" clId="{2040446B-C38A-46C4-B01C-56E514B30C92}" dt="2021-09-28T10:43:35.693" v="0" actId="478"/>
          <ac:spMkLst>
            <pc:docMk/>
            <pc:sldMk cId="594491241" sldId="257"/>
            <ac:spMk id="9" creationId="{92B0196B-CAD2-4732-A27C-7B32BE95AE92}"/>
          </ac:spMkLst>
        </pc:spChg>
        <pc:spChg chg="del">
          <ac:chgData name="Liu Wei-Xin" userId="355868643b3debea" providerId="LiveId" clId="{2040446B-C38A-46C4-B01C-56E514B30C92}" dt="2021-09-28T10:43:35.693" v="0" actId="478"/>
          <ac:spMkLst>
            <pc:docMk/>
            <pc:sldMk cId="594491241" sldId="257"/>
            <ac:spMk id="12" creationId="{F02E61AD-4040-441B-9C45-A8A1E31BE943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13" creationId="{6DA722CE-6F66-4C09-876B-7CA127873606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14" creationId="{51DADA9C-4D0A-4AD8-B206-C71D0970B4CD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16" creationId="{E0823189-9581-4788-A3EA-C11BE7E01D5E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17" creationId="{77C2A4EF-9FFA-474B-9BE8-91333D2412CE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21" creationId="{0FBB11C3-F369-4435-BFE5-CB8D0E2396AF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23" creationId="{7C923286-DA90-498B-B5EB-96C8C5B03D26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24" creationId="{C5836651-1085-43F8-9886-274212AB2B2B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25" creationId="{3E983082-2E08-4AE9-82F7-D99ED68A3127}"/>
          </ac:spMkLst>
        </pc:spChg>
        <pc:spChg chg="add mod">
          <ac:chgData name="Liu Wei-Xin" userId="355868643b3debea" providerId="LiveId" clId="{2040446B-C38A-46C4-B01C-56E514B30C92}" dt="2021-09-28T10:48:48.362" v="134" actId="1076"/>
          <ac:spMkLst>
            <pc:docMk/>
            <pc:sldMk cId="594491241" sldId="257"/>
            <ac:spMk id="26" creationId="{B34FCC11-735E-48F0-898E-A519DE3929AC}"/>
          </ac:spMkLst>
        </pc:spChg>
        <pc:spChg chg="add mod">
          <ac:chgData name="Liu Wei-Xin" userId="355868643b3debea" providerId="LiveId" clId="{2040446B-C38A-46C4-B01C-56E514B30C92}" dt="2021-09-28T10:56:07.357" v="463" actId="20577"/>
          <ac:spMkLst>
            <pc:docMk/>
            <pc:sldMk cId="594491241" sldId="257"/>
            <ac:spMk id="28" creationId="{CF17A099-66B7-4B78-BBD0-F0DC658EDC91}"/>
          </ac:spMkLst>
        </pc:spChg>
        <pc:graphicFrameChg chg="del">
          <ac:chgData name="Liu Wei-Xin" userId="355868643b3debea" providerId="LiveId" clId="{2040446B-C38A-46C4-B01C-56E514B30C92}" dt="2021-09-28T10:43:35.693" v="0" actId="478"/>
          <ac:graphicFrameMkLst>
            <pc:docMk/>
            <pc:sldMk cId="594491241" sldId="257"/>
            <ac:graphicFrameMk id="3" creationId="{02D514CA-CF19-45B8-9C76-A55E0D3715C4}"/>
          </ac:graphicFrameMkLst>
        </pc:graphicFrameChg>
        <pc:picChg chg="add mod modCrop">
          <ac:chgData name="Liu Wei-Xin" userId="355868643b3debea" providerId="LiveId" clId="{2040446B-C38A-46C4-B01C-56E514B30C92}" dt="2021-09-28T10:48:48.362" v="134" actId="1076"/>
          <ac:picMkLst>
            <pc:docMk/>
            <pc:sldMk cId="594491241" sldId="257"/>
            <ac:picMk id="4" creationId="{730EEF57-58E9-4653-8882-F5A8F5C8C0A2}"/>
          </ac:picMkLst>
        </pc:picChg>
        <pc:picChg chg="add mod modCrop">
          <ac:chgData name="Liu Wei-Xin" userId="355868643b3debea" providerId="LiveId" clId="{2040446B-C38A-46C4-B01C-56E514B30C92}" dt="2021-09-28T10:48:48.362" v="134" actId="1076"/>
          <ac:picMkLst>
            <pc:docMk/>
            <pc:sldMk cId="594491241" sldId="257"/>
            <ac:picMk id="6" creationId="{D90A874A-4D1F-4F23-B1DB-8D8993390317}"/>
          </ac:picMkLst>
        </pc:picChg>
        <pc:cxnChg chg="add mod">
          <ac:chgData name="Liu Wei-Xin" userId="355868643b3debea" providerId="LiveId" clId="{2040446B-C38A-46C4-B01C-56E514B30C92}" dt="2021-09-28T10:48:48.362" v="134" actId="1076"/>
          <ac:cxnSpMkLst>
            <pc:docMk/>
            <pc:sldMk cId="594491241" sldId="257"/>
            <ac:cxnSpMk id="10" creationId="{2F5A73B7-071D-4251-9478-1ECD914FB0DF}"/>
          </ac:cxnSpMkLst>
        </pc:cxnChg>
        <pc:cxnChg chg="add mod">
          <ac:chgData name="Liu Wei-Xin" userId="355868643b3debea" providerId="LiveId" clId="{2040446B-C38A-46C4-B01C-56E514B30C92}" dt="2021-09-28T10:48:48.362" v="134" actId="1076"/>
          <ac:cxnSpMkLst>
            <pc:docMk/>
            <pc:sldMk cId="594491241" sldId="257"/>
            <ac:cxnSpMk id="18" creationId="{C000A269-B9BC-4CC9-9A3A-63E368B3E4F5}"/>
          </ac:cxnSpMkLst>
        </pc:cxnChg>
        <pc:cxnChg chg="add mod">
          <ac:chgData name="Liu Wei-Xin" userId="355868643b3debea" providerId="LiveId" clId="{2040446B-C38A-46C4-B01C-56E514B30C92}" dt="2021-09-28T10:48:48.362" v="134" actId="1076"/>
          <ac:cxnSpMkLst>
            <pc:docMk/>
            <pc:sldMk cId="594491241" sldId="257"/>
            <ac:cxnSpMk id="22" creationId="{FAF9BEAA-9CEE-4009-90FA-22C1A34042A4}"/>
          </ac:cxnSpMkLst>
        </pc:cxnChg>
        <pc:cxnChg chg="add mod">
          <ac:chgData name="Liu Wei-Xin" userId="355868643b3debea" providerId="LiveId" clId="{2040446B-C38A-46C4-B01C-56E514B30C92}" dt="2021-09-28T10:48:48.362" v="134" actId="1076"/>
          <ac:cxnSpMkLst>
            <pc:docMk/>
            <pc:sldMk cId="594491241" sldId="257"/>
            <ac:cxnSpMk id="27" creationId="{3019866B-D76B-4D49-B57E-75B97E5301F3}"/>
          </ac:cxnSpMkLst>
        </pc:cxnChg>
      </pc:sldChg>
    </pc:docChg>
  </pc:docChgLst>
  <pc:docChgLst>
    <pc:chgData name="Liu Wei-Xin" userId="355868643b3debea" providerId="LiveId" clId="{2D6BB1C3-660B-4339-A8AB-444F9AB68438}"/>
    <pc:docChg chg="undo redo custSel modSld">
      <pc:chgData name="Liu Wei-Xin" userId="355868643b3debea" providerId="LiveId" clId="{2D6BB1C3-660B-4339-A8AB-444F9AB68438}" dt="2021-10-20T09:00:18.302" v="318" actId="20577"/>
      <pc:docMkLst>
        <pc:docMk/>
      </pc:docMkLst>
      <pc:sldChg chg="addSp delSp modSp mod">
        <pc:chgData name="Liu Wei-Xin" userId="355868643b3debea" providerId="LiveId" clId="{2D6BB1C3-660B-4339-A8AB-444F9AB68438}" dt="2021-10-20T09:00:18.302" v="318" actId="20577"/>
        <pc:sldMkLst>
          <pc:docMk/>
          <pc:sldMk cId="594491241" sldId="257"/>
        </pc:sldMkLst>
        <pc:spChg chg="add del mod">
          <ac:chgData name="Liu Wei-Xin" userId="355868643b3debea" providerId="LiveId" clId="{2D6BB1C3-660B-4339-A8AB-444F9AB68438}" dt="2021-09-28T11:33:57.785" v="11" actId="478"/>
          <ac:spMkLst>
            <pc:docMk/>
            <pc:sldMk cId="594491241" sldId="257"/>
            <ac:spMk id="2" creationId="{46349AEF-8B1C-4961-9F8B-8357B4460CF1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7" creationId="{91287A24-18DF-4A67-88CE-B8746DB9FB98}"/>
          </ac:spMkLst>
        </pc:spChg>
        <pc:spChg chg="add mod">
          <ac:chgData name="Liu Wei-Xin" userId="355868643b3debea" providerId="LiveId" clId="{2D6BB1C3-660B-4339-A8AB-444F9AB68438}" dt="2021-09-29T08:29:26.832" v="113" actId="14100"/>
          <ac:spMkLst>
            <pc:docMk/>
            <pc:sldMk cId="594491241" sldId="257"/>
            <ac:spMk id="8" creationId="{7FBAA2CA-2A6D-4558-88B4-CBC898C41BA7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13" creationId="{6DA722CE-6F66-4C09-876B-7CA127873606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14" creationId="{51DADA9C-4D0A-4AD8-B206-C71D0970B4CD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16" creationId="{E0823189-9581-4788-A3EA-C11BE7E01D5E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17" creationId="{77C2A4EF-9FFA-474B-9BE8-91333D2412CE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21" creationId="{0FBB11C3-F369-4435-BFE5-CB8D0E2396AF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23" creationId="{7C923286-DA90-498B-B5EB-96C8C5B03D26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24" creationId="{C5836651-1085-43F8-9886-274212AB2B2B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25" creationId="{3E983082-2E08-4AE9-82F7-D99ED68A3127}"/>
          </ac:spMkLst>
        </pc:spChg>
        <pc:spChg chg="del">
          <ac:chgData name="Liu Wei-Xin" userId="355868643b3debea" providerId="LiveId" clId="{2D6BB1C3-660B-4339-A8AB-444F9AB68438}" dt="2021-09-28T11:25:41.391" v="2" actId="478"/>
          <ac:spMkLst>
            <pc:docMk/>
            <pc:sldMk cId="594491241" sldId="257"/>
            <ac:spMk id="26" creationId="{B34FCC11-735E-48F0-898E-A519DE3929AC}"/>
          </ac:spMkLst>
        </pc:spChg>
        <pc:spChg chg="mod">
          <ac:chgData name="Liu Wei-Xin" userId="355868643b3debea" providerId="LiveId" clId="{2D6BB1C3-660B-4339-A8AB-444F9AB68438}" dt="2021-10-20T09:00:18.302" v="318" actId="20577"/>
          <ac:spMkLst>
            <pc:docMk/>
            <pc:sldMk cId="594491241" sldId="257"/>
            <ac:spMk id="28" creationId="{CF17A099-66B7-4B78-BBD0-F0DC658EDC91}"/>
          </ac:spMkLst>
        </pc:spChg>
        <pc:spChg chg="add mod">
          <ac:chgData name="Liu Wei-Xin" userId="355868643b3debea" providerId="LiveId" clId="{2D6BB1C3-660B-4339-A8AB-444F9AB68438}" dt="2021-09-29T08:07:02.349" v="112" actId="1076"/>
          <ac:spMkLst>
            <pc:docMk/>
            <pc:sldMk cId="594491241" sldId="257"/>
            <ac:spMk id="29" creationId="{7DF68198-76E7-4018-B093-E8F48EB1BC73}"/>
          </ac:spMkLst>
        </pc:spChg>
        <pc:spChg chg="add mod">
          <ac:chgData name="Liu Wei-Xin" userId="355868643b3debea" providerId="LiveId" clId="{2D6BB1C3-660B-4339-A8AB-444F9AB68438}" dt="2021-09-29T08:07:02.349" v="112" actId="1076"/>
          <ac:spMkLst>
            <pc:docMk/>
            <pc:sldMk cId="594491241" sldId="257"/>
            <ac:spMk id="30" creationId="{C2392D1B-28CA-4947-B971-D50E8FBD05C3}"/>
          </ac:spMkLst>
        </pc:spChg>
        <pc:spChg chg="add mod">
          <ac:chgData name="Liu Wei-Xin" userId="355868643b3debea" providerId="LiveId" clId="{2D6BB1C3-660B-4339-A8AB-444F9AB68438}" dt="2021-09-29T08:07:02.349" v="112" actId="1076"/>
          <ac:spMkLst>
            <pc:docMk/>
            <pc:sldMk cId="594491241" sldId="257"/>
            <ac:spMk id="31" creationId="{87AECD9F-0A20-43F0-9612-4AEEA3684AA5}"/>
          </ac:spMkLst>
        </pc:spChg>
        <pc:spChg chg="add mod">
          <ac:chgData name="Liu Wei-Xin" userId="355868643b3debea" providerId="LiveId" clId="{2D6BB1C3-660B-4339-A8AB-444F9AB68438}" dt="2021-09-29T08:07:02.349" v="112" actId="1076"/>
          <ac:spMkLst>
            <pc:docMk/>
            <pc:sldMk cId="594491241" sldId="257"/>
            <ac:spMk id="34" creationId="{7BEAEB25-D60C-4590-80D4-8B2A1C539518}"/>
          </ac:spMkLst>
        </pc:spChg>
        <pc:spChg chg="add mod">
          <ac:chgData name="Liu Wei-Xin" userId="355868643b3debea" providerId="LiveId" clId="{2D6BB1C3-660B-4339-A8AB-444F9AB68438}" dt="2021-09-29T08:07:02.349" v="112" actId="1076"/>
          <ac:spMkLst>
            <pc:docMk/>
            <pc:sldMk cId="594491241" sldId="257"/>
            <ac:spMk id="35" creationId="{C340A50C-8DEF-4E35-A1FA-70AE9FBF1740}"/>
          </ac:spMkLst>
        </pc:spChg>
        <pc:spChg chg="add mod">
          <ac:chgData name="Liu Wei-Xin" userId="355868643b3debea" providerId="LiveId" clId="{2D6BB1C3-660B-4339-A8AB-444F9AB68438}" dt="2021-09-29T08:07:02.349" v="112" actId="1076"/>
          <ac:spMkLst>
            <pc:docMk/>
            <pc:sldMk cId="594491241" sldId="257"/>
            <ac:spMk id="36" creationId="{BE8EE027-7BE6-4ED0-A2E3-DE69C72295CB}"/>
          </ac:spMkLst>
        </pc:spChg>
        <pc:spChg chg="add del mod">
          <ac:chgData name="Liu Wei-Xin" userId="355868643b3debea" providerId="LiveId" clId="{2D6BB1C3-660B-4339-A8AB-444F9AB68438}" dt="2021-09-28T11:33:57.785" v="11" actId="478"/>
          <ac:spMkLst>
            <pc:docMk/>
            <pc:sldMk cId="594491241" sldId="257"/>
            <ac:spMk id="37" creationId="{907E6CB0-5467-4AA1-9396-A21B7D303AC7}"/>
          </ac:spMkLst>
        </pc:spChg>
        <pc:spChg chg="add mod">
          <ac:chgData name="Liu Wei-Xin" userId="355868643b3debea" providerId="LiveId" clId="{2D6BB1C3-660B-4339-A8AB-444F9AB68438}" dt="2021-09-29T10:37:08.419" v="116" actId="1038"/>
          <ac:spMkLst>
            <pc:docMk/>
            <pc:sldMk cId="594491241" sldId="257"/>
            <ac:spMk id="38" creationId="{C849896D-A0C4-4439-8614-7405C0E95285}"/>
          </ac:spMkLst>
        </pc:spChg>
        <pc:spChg chg="add del mod">
          <ac:chgData name="Liu Wei-Xin" userId="355868643b3debea" providerId="LiveId" clId="{2D6BB1C3-660B-4339-A8AB-444F9AB68438}" dt="2021-09-28T11:36:34.864" v="34" actId="478"/>
          <ac:spMkLst>
            <pc:docMk/>
            <pc:sldMk cId="594491241" sldId="257"/>
            <ac:spMk id="39" creationId="{2C51E6A4-EC26-406F-8232-C82D8FAD74B7}"/>
          </ac:spMkLst>
        </pc:spChg>
        <pc:spChg chg="add del mod">
          <ac:chgData name="Liu Wei-Xin" userId="355868643b3debea" providerId="LiveId" clId="{2D6BB1C3-660B-4339-A8AB-444F9AB68438}" dt="2021-09-28T11:35:47.377" v="22" actId="478"/>
          <ac:spMkLst>
            <pc:docMk/>
            <pc:sldMk cId="594491241" sldId="257"/>
            <ac:spMk id="40" creationId="{5796C025-12CE-4975-9769-F7B349E879C6}"/>
          </ac:spMkLst>
        </pc:spChg>
        <pc:spChg chg="add mod">
          <ac:chgData name="Liu Wei-Xin" userId="355868643b3debea" providerId="LiveId" clId="{2D6BB1C3-660B-4339-A8AB-444F9AB68438}" dt="2021-09-29T08:06:48.598" v="105" actId="122"/>
          <ac:spMkLst>
            <pc:docMk/>
            <pc:sldMk cId="594491241" sldId="257"/>
            <ac:spMk id="41" creationId="{175E980B-1D90-491C-A07C-AAB079EB2CF1}"/>
          </ac:spMkLst>
        </pc:spChg>
        <pc:spChg chg="add mod">
          <ac:chgData name="Liu Wei-Xin" userId="355868643b3debea" providerId="LiveId" clId="{2D6BB1C3-660B-4339-A8AB-444F9AB68438}" dt="2021-09-29T08:06:58.169" v="111"/>
          <ac:spMkLst>
            <pc:docMk/>
            <pc:sldMk cId="594491241" sldId="257"/>
            <ac:spMk id="42" creationId="{B1F7AD3C-7B4D-4F1C-BF82-76775AFF34D6}"/>
          </ac:spMkLst>
        </pc:spChg>
        <pc:picChg chg="del">
          <ac:chgData name="Liu Wei-Xin" userId="355868643b3debea" providerId="LiveId" clId="{2D6BB1C3-660B-4339-A8AB-444F9AB68438}" dt="2021-09-28T11:25:41.391" v="2" actId="478"/>
          <ac:picMkLst>
            <pc:docMk/>
            <pc:sldMk cId="594491241" sldId="257"/>
            <ac:picMk id="4" creationId="{730EEF57-58E9-4653-8882-F5A8F5C8C0A2}"/>
          </ac:picMkLst>
        </pc:picChg>
        <pc:picChg chg="del">
          <ac:chgData name="Liu Wei-Xin" userId="355868643b3debea" providerId="LiveId" clId="{2D6BB1C3-660B-4339-A8AB-444F9AB68438}" dt="2021-09-28T11:25:41.391" v="2" actId="478"/>
          <ac:picMkLst>
            <pc:docMk/>
            <pc:sldMk cId="594491241" sldId="257"/>
            <ac:picMk id="6" creationId="{D90A874A-4D1F-4F23-B1DB-8D8993390317}"/>
          </ac:picMkLst>
        </pc:picChg>
        <pc:picChg chg="add mod">
          <ac:chgData name="Liu Wei-Xin" userId="355868643b3debea" providerId="LiveId" clId="{2D6BB1C3-660B-4339-A8AB-444F9AB68438}" dt="2021-09-29T08:07:02.349" v="112" actId="1076"/>
          <ac:picMkLst>
            <pc:docMk/>
            <pc:sldMk cId="594491241" sldId="257"/>
            <ac:picMk id="19" creationId="{9CA385BB-0C90-4F79-A77B-141D08CC0DA0}"/>
          </ac:picMkLst>
        </pc:picChg>
        <pc:picChg chg="add mod modCrop">
          <ac:chgData name="Liu Wei-Xin" userId="355868643b3debea" providerId="LiveId" clId="{2D6BB1C3-660B-4339-A8AB-444F9AB68438}" dt="2021-09-29T08:07:02.349" v="112" actId="1076"/>
          <ac:picMkLst>
            <pc:docMk/>
            <pc:sldMk cId="594491241" sldId="257"/>
            <ac:picMk id="20" creationId="{CB8BA292-D6DD-4E4E-AE89-08A3EB02CA10}"/>
          </ac:picMkLst>
        </pc:picChg>
        <pc:picChg chg="add mod modCrop">
          <ac:chgData name="Liu Wei-Xin" userId="355868643b3debea" providerId="LiveId" clId="{2D6BB1C3-660B-4339-A8AB-444F9AB68438}" dt="2021-09-29T08:07:02.349" v="112" actId="1076"/>
          <ac:picMkLst>
            <pc:docMk/>
            <pc:sldMk cId="594491241" sldId="257"/>
            <ac:picMk id="32" creationId="{A8E4C5ED-FAEF-4EB3-A847-E528C48DB791}"/>
          </ac:picMkLst>
        </pc:picChg>
        <pc:picChg chg="add mod modCrop">
          <ac:chgData name="Liu Wei-Xin" userId="355868643b3debea" providerId="LiveId" clId="{2D6BB1C3-660B-4339-A8AB-444F9AB68438}" dt="2021-09-29T08:07:02.349" v="112" actId="1076"/>
          <ac:picMkLst>
            <pc:docMk/>
            <pc:sldMk cId="594491241" sldId="257"/>
            <ac:picMk id="33" creationId="{8CA1FA40-05F4-4855-B526-DE92604B39E5}"/>
          </ac:picMkLst>
        </pc:picChg>
        <pc:cxnChg chg="add del">
          <ac:chgData name="Liu Wei-Xin" userId="355868643b3debea" providerId="LiveId" clId="{2D6BB1C3-660B-4339-A8AB-444F9AB68438}" dt="2021-09-28T11:34:57.778" v="13" actId="11529"/>
          <ac:cxnSpMkLst>
            <pc:docMk/>
            <pc:sldMk cId="594491241" sldId="257"/>
            <ac:cxnSpMk id="5" creationId="{FFAB2292-889D-4BCD-AC32-58768C63A590}"/>
          </ac:cxnSpMkLst>
        </pc:cxnChg>
        <pc:cxnChg chg="del">
          <ac:chgData name="Liu Wei-Xin" userId="355868643b3debea" providerId="LiveId" clId="{2D6BB1C3-660B-4339-A8AB-444F9AB68438}" dt="2021-09-28T11:25:41.391" v="2" actId="478"/>
          <ac:cxnSpMkLst>
            <pc:docMk/>
            <pc:sldMk cId="594491241" sldId="257"/>
            <ac:cxnSpMk id="10" creationId="{2F5A73B7-071D-4251-9478-1ECD914FB0DF}"/>
          </ac:cxnSpMkLst>
        </pc:cxnChg>
        <pc:cxnChg chg="del">
          <ac:chgData name="Liu Wei-Xin" userId="355868643b3debea" providerId="LiveId" clId="{2D6BB1C3-660B-4339-A8AB-444F9AB68438}" dt="2021-09-28T11:25:41.391" v="2" actId="478"/>
          <ac:cxnSpMkLst>
            <pc:docMk/>
            <pc:sldMk cId="594491241" sldId="257"/>
            <ac:cxnSpMk id="18" creationId="{C000A269-B9BC-4CC9-9A3A-63E368B3E4F5}"/>
          </ac:cxnSpMkLst>
        </pc:cxnChg>
        <pc:cxnChg chg="del">
          <ac:chgData name="Liu Wei-Xin" userId="355868643b3debea" providerId="LiveId" clId="{2D6BB1C3-660B-4339-A8AB-444F9AB68438}" dt="2021-09-28T11:25:41.391" v="2" actId="478"/>
          <ac:cxnSpMkLst>
            <pc:docMk/>
            <pc:sldMk cId="594491241" sldId="257"/>
            <ac:cxnSpMk id="22" creationId="{FAF9BEAA-9CEE-4009-90FA-22C1A34042A4}"/>
          </ac:cxnSpMkLst>
        </pc:cxnChg>
        <pc:cxnChg chg="del">
          <ac:chgData name="Liu Wei-Xin" userId="355868643b3debea" providerId="LiveId" clId="{2D6BB1C3-660B-4339-A8AB-444F9AB68438}" dt="2021-09-28T11:25:41.391" v="2" actId="478"/>
          <ac:cxnSpMkLst>
            <pc:docMk/>
            <pc:sldMk cId="594491241" sldId="257"/>
            <ac:cxnSpMk id="27" creationId="{3019866B-D76B-4D49-B57E-75B97E5301F3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F7E645-F4C3-4B69-9342-CFFB532CCD99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85875" y="685800"/>
            <a:ext cx="42862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4D9D15-D982-447C-9B58-7E2F227BCF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3545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841450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682900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2524347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3365801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4207252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5048701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5890149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6731599" algn="l" defTabSz="1682900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285875" y="685800"/>
            <a:ext cx="42862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C6C5DB1-74F7-4B65-8E9D-75E9BDA9AC7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035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236465"/>
            <a:ext cx="7649607" cy="154318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31" y="4079611"/>
            <a:ext cx="6299677" cy="183982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77943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5588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3383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1177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8971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6766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4560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235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780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003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24666" y="288323"/>
            <a:ext cx="2024896" cy="61427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9977" y="288323"/>
            <a:ext cx="5924696" cy="61427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249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0371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0901" y="4626231"/>
            <a:ext cx="7649607" cy="1429864"/>
          </a:xfrm>
        </p:spPr>
        <p:txBody>
          <a:bodyPr anchor="t"/>
          <a:lstStyle>
            <a:lvl1pPr algn="l">
              <a:defRPr sz="6855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0901" y="3051380"/>
            <a:ext cx="7649607" cy="1574850"/>
          </a:xfrm>
        </p:spPr>
        <p:txBody>
          <a:bodyPr anchor="b"/>
          <a:lstStyle>
            <a:lvl1pPr marL="0" indent="0">
              <a:buNone/>
              <a:defRPr sz="3613">
                <a:solidFill>
                  <a:schemeClr val="tx1">
                    <a:tint val="75000"/>
                  </a:schemeClr>
                </a:solidFill>
              </a:defRPr>
            </a:lvl1pPr>
            <a:lvl2pPr marL="779435" indent="0">
              <a:buNone/>
              <a:defRPr sz="3057">
                <a:solidFill>
                  <a:schemeClr val="tx1">
                    <a:tint val="75000"/>
                  </a:schemeClr>
                </a:solidFill>
              </a:defRPr>
            </a:lvl2pPr>
            <a:lvl3pPr marL="1558870" indent="0">
              <a:buNone/>
              <a:defRPr sz="2872">
                <a:solidFill>
                  <a:schemeClr val="tx1">
                    <a:tint val="75000"/>
                  </a:schemeClr>
                </a:solidFill>
              </a:defRPr>
            </a:lvl3pPr>
            <a:lvl4pPr marL="2338303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4pPr>
            <a:lvl5pPr marL="3117741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5pPr>
            <a:lvl6pPr marL="3897178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6pPr>
            <a:lvl7pPr marL="4676612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7pPr>
            <a:lvl8pPr marL="5456045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8pPr>
            <a:lvl9pPr marL="6235480" indent="0">
              <a:buNone/>
              <a:defRPr sz="21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809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9977" y="1679851"/>
            <a:ext cx="3974796" cy="4751216"/>
          </a:xfrm>
        </p:spPr>
        <p:txBody>
          <a:bodyPr/>
          <a:lstStyle>
            <a:lvl1pPr>
              <a:defRPr sz="4724"/>
            </a:lvl1pPr>
            <a:lvl2pPr>
              <a:defRPr sz="3983"/>
            </a:lvl2pPr>
            <a:lvl3pPr>
              <a:defRPr sz="3613"/>
            </a:lvl3pPr>
            <a:lvl4pPr>
              <a:defRPr sz="3057"/>
            </a:lvl4pPr>
            <a:lvl5pPr>
              <a:defRPr sz="3057"/>
            </a:lvl5pPr>
            <a:lvl6pPr>
              <a:defRPr sz="3057"/>
            </a:lvl6pPr>
            <a:lvl7pPr>
              <a:defRPr sz="3057"/>
            </a:lvl7pPr>
            <a:lvl8pPr>
              <a:defRPr sz="3057"/>
            </a:lvl8pPr>
            <a:lvl9pPr>
              <a:defRPr sz="305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4765" y="1679851"/>
            <a:ext cx="3974796" cy="4751216"/>
          </a:xfrm>
        </p:spPr>
        <p:txBody>
          <a:bodyPr/>
          <a:lstStyle>
            <a:lvl1pPr>
              <a:defRPr sz="4724"/>
            </a:lvl1pPr>
            <a:lvl2pPr>
              <a:defRPr sz="3983"/>
            </a:lvl2pPr>
            <a:lvl3pPr>
              <a:defRPr sz="3613"/>
            </a:lvl3pPr>
            <a:lvl4pPr>
              <a:defRPr sz="3057"/>
            </a:lvl4pPr>
            <a:lvl5pPr>
              <a:defRPr sz="3057"/>
            </a:lvl5pPr>
            <a:lvl6pPr>
              <a:defRPr sz="3057"/>
            </a:lvl6pPr>
            <a:lvl7pPr>
              <a:defRPr sz="3057"/>
            </a:lvl7pPr>
            <a:lvl8pPr>
              <a:defRPr sz="3057"/>
            </a:lvl8pPr>
            <a:lvl9pPr>
              <a:defRPr sz="305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180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9980" y="1611513"/>
            <a:ext cx="3976362" cy="671605"/>
          </a:xfrm>
        </p:spPr>
        <p:txBody>
          <a:bodyPr anchor="b"/>
          <a:lstStyle>
            <a:lvl1pPr marL="0" indent="0">
              <a:buNone/>
              <a:defRPr sz="3983" b="1"/>
            </a:lvl1pPr>
            <a:lvl2pPr marL="779435" indent="0">
              <a:buNone/>
              <a:defRPr sz="3613" b="1"/>
            </a:lvl2pPr>
            <a:lvl3pPr marL="1558870" indent="0">
              <a:buNone/>
              <a:defRPr sz="3057" b="1"/>
            </a:lvl3pPr>
            <a:lvl4pPr marL="2338303" indent="0">
              <a:buNone/>
              <a:defRPr sz="2872" b="1"/>
            </a:lvl4pPr>
            <a:lvl5pPr marL="3117741" indent="0">
              <a:buNone/>
              <a:defRPr sz="2872" b="1"/>
            </a:lvl5pPr>
            <a:lvl6pPr marL="3897178" indent="0">
              <a:buNone/>
              <a:defRPr sz="2872" b="1"/>
            </a:lvl6pPr>
            <a:lvl7pPr marL="4676612" indent="0">
              <a:buNone/>
              <a:defRPr sz="2872" b="1"/>
            </a:lvl7pPr>
            <a:lvl8pPr marL="5456045" indent="0">
              <a:buNone/>
              <a:defRPr sz="2872" b="1"/>
            </a:lvl8pPr>
            <a:lvl9pPr marL="6235480" indent="0">
              <a:buNone/>
              <a:defRPr sz="287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9980" y="2283120"/>
            <a:ext cx="3976362" cy="4147940"/>
          </a:xfrm>
        </p:spPr>
        <p:txBody>
          <a:bodyPr/>
          <a:lstStyle>
            <a:lvl1pPr>
              <a:defRPr sz="3983"/>
            </a:lvl1pPr>
            <a:lvl2pPr>
              <a:defRPr sz="3613"/>
            </a:lvl2pPr>
            <a:lvl3pPr>
              <a:defRPr sz="3057"/>
            </a:lvl3pPr>
            <a:lvl4pPr>
              <a:defRPr sz="2872"/>
            </a:lvl4pPr>
            <a:lvl5pPr>
              <a:defRPr sz="2872"/>
            </a:lvl5pPr>
            <a:lvl6pPr>
              <a:defRPr sz="2872"/>
            </a:lvl6pPr>
            <a:lvl7pPr>
              <a:defRPr sz="2872"/>
            </a:lvl7pPr>
            <a:lvl8pPr>
              <a:defRPr sz="2872"/>
            </a:lvl8pPr>
            <a:lvl9pPr>
              <a:defRPr sz="287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71645" y="1611513"/>
            <a:ext cx="3977922" cy="671605"/>
          </a:xfrm>
        </p:spPr>
        <p:txBody>
          <a:bodyPr anchor="b"/>
          <a:lstStyle>
            <a:lvl1pPr marL="0" indent="0">
              <a:buNone/>
              <a:defRPr sz="3983" b="1"/>
            </a:lvl1pPr>
            <a:lvl2pPr marL="779435" indent="0">
              <a:buNone/>
              <a:defRPr sz="3613" b="1"/>
            </a:lvl2pPr>
            <a:lvl3pPr marL="1558870" indent="0">
              <a:buNone/>
              <a:defRPr sz="3057" b="1"/>
            </a:lvl3pPr>
            <a:lvl4pPr marL="2338303" indent="0">
              <a:buNone/>
              <a:defRPr sz="2872" b="1"/>
            </a:lvl4pPr>
            <a:lvl5pPr marL="3117741" indent="0">
              <a:buNone/>
              <a:defRPr sz="2872" b="1"/>
            </a:lvl5pPr>
            <a:lvl6pPr marL="3897178" indent="0">
              <a:buNone/>
              <a:defRPr sz="2872" b="1"/>
            </a:lvl6pPr>
            <a:lvl7pPr marL="4676612" indent="0">
              <a:buNone/>
              <a:defRPr sz="2872" b="1"/>
            </a:lvl7pPr>
            <a:lvl8pPr marL="5456045" indent="0">
              <a:buNone/>
              <a:defRPr sz="2872" b="1"/>
            </a:lvl8pPr>
            <a:lvl9pPr marL="6235480" indent="0">
              <a:buNone/>
              <a:defRPr sz="287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71645" y="2283120"/>
            <a:ext cx="3977922" cy="4147940"/>
          </a:xfrm>
        </p:spPr>
        <p:txBody>
          <a:bodyPr/>
          <a:lstStyle>
            <a:lvl1pPr>
              <a:defRPr sz="3983"/>
            </a:lvl1pPr>
            <a:lvl2pPr>
              <a:defRPr sz="3613"/>
            </a:lvl2pPr>
            <a:lvl3pPr>
              <a:defRPr sz="3057"/>
            </a:lvl3pPr>
            <a:lvl4pPr>
              <a:defRPr sz="2872"/>
            </a:lvl4pPr>
            <a:lvl5pPr>
              <a:defRPr sz="2872"/>
            </a:lvl5pPr>
            <a:lvl6pPr>
              <a:defRPr sz="2872"/>
            </a:lvl6pPr>
            <a:lvl7pPr>
              <a:defRPr sz="2872"/>
            </a:lvl7pPr>
            <a:lvl8pPr>
              <a:defRPr sz="2872"/>
            </a:lvl8pPr>
            <a:lvl9pPr>
              <a:defRPr sz="287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771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1827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6717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9988" y="286642"/>
            <a:ext cx="2960786" cy="1219884"/>
          </a:xfrm>
        </p:spPr>
        <p:txBody>
          <a:bodyPr anchor="b"/>
          <a:lstStyle>
            <a:lvl1pPr algn="l">
              <a:defRPr sz="3613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18574" y="286643"/>
            <a:ext cx="5030993" cy="6144414"/>
          </a:xfrm>
        </p:spPr>
        <p:txBody>
          <a:bodyPr/>
          <a:lstStyle>
            <a:lvl1pPr>
              <a:defRPr sz="5465"/>
            </a:lvl1pPr>
            <a:lvl2pPr>
              <a:defRPr sz="4724"/>
            </a:lvl2pPr>
            <a:lvl3pPr>
              <a:defRPr sz="3983"/>
            </a:lvl3pPr>
            <a:lvl4pPr>
              <a:defRPr sz="3613"/>
            </a:lvl4pPr>
            <a:lvl5pPr>
              <a:defRPr sz="3613"/>
            </a:lvl5pPr>
            <a:lvl6pPr>
              <a:defRPr sz="3613"/>
            </a:lvl6pPr>
            <a:lvl7pPr>
              <a:defRPr sz="3613"/>
            </a:lvl7pPr>
            <a:lvl8pPr>
              <a:defRPr sz="3613"/>
            </a:lvl8pPr>
            <a:lvl9pPr>
              <a:defRPr sz="361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9988" y="1506527"/>
            <a:ext cx="2960786" cy="4924531"/>
          </a:xfrm>
        </p:spPr>
        <p:txBody>
          <a:bodyPr/>
          <a:lstStyle>
            <a:lvl1pPr marL="0" indent="0">
              <a:buNone/>
              <a:defRPr sz="2130"/>
            </a:lvl1pPr>
            <a:lvl2pPr marL="779435" indent="0">
              <a:buNone/>
              <a:defRPr sz="1853"/>
            </a:lvl2pPr>
            <a:lvl3pPr marL="1558870" indent="0">
              <a:buNone/>
              <a:defRPr sz="1667"/>
            </a:lvl3pPr>
            <a:lvl4pPr marL="2338303" indent="0">
              <a:buNone/>
              <a:defRPr sz="1667"/>
            </a:lvl4pPr>
            <a:lvl5pPr marL="3117741" indent="0">
              <a:buNone/>
              <a:defRPr sz="1667"/>
            </a:lvl5pPr>
            <a:lvl6pPr marL="3897178" indent="0">
              <a:buNone/>
              <a:defRPr sz="1667"/>
            </a:lvl6pPr>
            <a:lvl7pPr marL="4676612" indent="0">
              <a:buNone/>
              <a:defRPr sz="1667"/>
            </a:lvl7pPr>
            <a:lvl8pPr marL="5456045" indent="0">
              <a:buNone/>
              <a:defRPr sz="1667"/>
            </a:lvl8pPr>
            <a:lvl9pPr marL="6235480" indent="0">
              <a:buNone/>
              <a:defRPr sz="16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115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3975" y="5039520"/>
            <a:ext cx="5399723" cy="594944"/>
          </a:xfrm>
        </p:spPr>
        <p:txBody>
          <a:bodyPr anchor="b"/>
          <a:lstStyle>
            <a:lvl1pPr algn="l">
              <a:defRPr sz="3613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63975" y="643272"/>
            <a:ext cx="5399723" cy="4319588"/>
          </a:xfrm>
        </p:spPr>
        <p:txBody>
          <a:bodyPr/>
          <a:lstStyle>
            <a:lvl1pPr marL="0" indent="0">
              <a:buNone/>
              <a:defRPr sz="5465"/>
            </a:lvl1pPr>
            <a:lvl2pPr marL="779435" indent="0">
              <a:buNone/>
              <a:defRPr sz="4724"/>
            </a:lvl2pPr>
            <a:lvl3pPr marL="1558870" indent="0">
              <a:buNone/>
              <a:defRPr sz="3983"/>
            </a:lvl3pPr>
            <a:lvl4pPr marL="2338303" indent="0">
              <a:buNone/>
              <a:defRPr sz="3613"/>
            </a:lvl4pPr>
            <a:lvl5pPr marL="3117741" indent="0">
              <a:buNone/>
              <a:defRPr sz="3613"/>
            </a:lvl5pPr>
            <a:lvl6pPr marL="3897178" indent="0">
              <a:buNone/>
              <a:defRPr sz="3613"/>
            </a:lvl6pPr>
            <a:lvl7pPr marL="4676612" indent="0">
              <a:buNone/>
              <a:defRPr sz="3613"/>
            </a:lvl7pPr>
            <a:lvl8pPr marL="5456045" indent="0">
              <a:buNone/>
              <a:defRPr sz="3613"/>
            </a:lvl8pPr>
            <a:lvl9pPr marL="6235480" indent="0">
              <a:buNone/>
              <a:defRPr sz="3613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63975" y="5634464"/>
            <a:ext cx="5399723" cy="844920"/>
          </a:xfrm>
        </p:spPr>
        <p:txBody>
          <a:bodyPr/>
          <a:lstStyle>
            <a:lvl1pPr marL="0" indent="0">
              <a:buNone/>
              <a:defRPr sz="2130"/>
            </a:lvl1pPr>
            <a:lvl2pPr marL="779435" indent="0">
              <a:buNone/>
              <a:defRPr sz="1853"/>
            </a:lvl2pPr>
            <a:lvl3pPr marL="1558870" indent="0">
              <a:buNone/>
              <a:defRPr sz="1667"/>
            </a:lvl3pPr>
            <a:lvl4pPr marL="2338303" indent="0">
              <a:buNone/>
              <a:defRPr sz="1667"/>
            </a:lvl4pPr>
            <a:lvl5pPr marL="3117741" indent="0">
              <a:buNone/>
              <a:defRPr sz="1667"/>
            </a:lvl5pPr>
            <a:lvl6pPr marL="3897178" indent="0">
              <a:buNone/>
              <a:defRPr sz="1667"/>
            </a:lvl6pPr>
            <a:lvl7pPr marL="4676612" indent="0">
              <a:buNone/>
              <a:defRPr sz="1667"/>
            </a:lvl7pPr>
            <a:lvl8pPr marL="5456045" indent="0">
              <a:buNone/>
              <a:defRPr sz="1667"/>
            </a:lvl8pPr>
            <a:lvl9pPr marL="6235480" indent="0">
              <a:buNone/>
              <a:defRPr sz="16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4205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9977" y="288309"/>
            <a:ext cx="8099585" cy="1199886"/>
          </a:xfrm>
          <a:prstGeom prst="rect">
            <a:avLst/>
          </a:prstGeom>
        </p:spPr>
        <p:txBody>
          <a:bodyPr vert="horz" lIns="168288" tIns="84145" rIns="168288" bIns="84145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9977" y="1679851"/>
            <a:ext cx="8099585" cy="4751216"/>
          </a:xfrm>
          <a:prstGeom prst="rect">
            <a:avLst/>
          </a:prstGeom>
        </p:spPr>
        <p:txBody>
          <a:bodyPr vert="horz" lIns="168288" tIns="84145" rIns="168288" bIns="84145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9977" y="6672707"/>
            <a:ext cx="2099892" cy="383296"/>
          </a:xfrm>
          <a:prstGeom prst="rect">
            <a:avLst/>
          </a:prstGeom>
        </p:spPr>
        <p:txBody>
          <a:bodyPr vert="horz" lIns="168288" tIns="84145" rIns="168288" bIns="84145" rtlCol="0" anchor="ctr"/>
          <a:lstStyle>
            <a:lvl1pPr algn="l">
              <a:defRPr sz="18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92D53-90AF-4892-BA73-D85962F90408}" type="datetimeFigureOut">
              <a:rPr lang="en-US" smtClean="0"/>
              <a:t>12/1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74843" y="6672707"/>
            <a:ext cx="2849854" cy="383296"/>
          </a:xfrm>
          <a:prstGeom prst="rect">
            <a:avLst/>
          </a:prstGeom>
        </p:spPr>
        <p:txBody>
          <a:bodyPr vert="horz" lIns="168288" tIns="84145" rIns="168288" bIns="84145" rtlCol="0" anchor="ctr"/>
          <a:lstStyle>
            <a:lvl1pPr algn="ctr">
              <a:defRPr sz="18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49669" y="6672707"/>
            <a:ext cx="2099892" cy="383296"/>
          </a:xfrm>
          <a:prstGeom prst="rect">
            <a:avLst/>
          </a:prstGeom>
        </p:spPr>
        <p:txBody>
          <a:bodyPr vert="horz" lIns="168288" tIns="84145" rIns="168288" bIns="84145" rtlCol="0" anchor="ctr"/>
          <a:lstStyle>
            <a:lvl1pPr algn="r">
              <a:defRPr sz="18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879B6-1E94-4295-9FD0-D3B282BD9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762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558870" rtl="0" eaLnBrk="1" latinLnBrk="0" hangingPunct="1">
        <a:spcBef>
          <a:spcPct val="0"/>
        </a:spcBef>
        <a:buNone/>
        <a:defRPr sz="74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84577" indent="-584577" algn="l" defTabSz="1558870" rtl="0" eaLnBrk="1" latinLnBrk="0" hangingPunct="1">
        <a:spcBef>
          <a:spcPct val="20000"/>
        </a:spcBef>
        <a:buFont typeface="Arial" panose="020B0604020202020204" pitchFamily="34" charset="0"/>
        <a:buChar char="•"/>
        <a:defRPr sz="5465" kern="1200">
          <a:solidFill>
            <a:schemeClr val="tx1"/>
          </a:solidFill>
          <a:latin typeface="+mn-lt"/>
          <a:ea typeface="+mn-ea"/>
          <a:cs typeface="+mn-cs"/>
        </a:defRPr>
      </a:lvl1pPr>
      <a:lvl2pPr marL="1266583" indent="-487147" algn="l" defTabSz="1558870" rtl="0" eaLnBrk="1" latinLnBrk="0" hangingPunct="1">
        <a:spcBef>
          <a:spcPct val="20000"/>
        </a:spcBef>
        <a:buFont typeface="Arial" panose="020B0604020202020204" pitchFamily="34" charset="0"/>
        <a:buChar char="–"/>
        <a:defRPr sz="4724" kern="1200">
          <a:solidFill>
            <a:schemeClr val="tx1"/>
          </a:solidFill>
          <a:latin typeface="+mn-lt"/>
          <a:ea typeface="+mn-ea"/>
          <a:cs typeface="+mn-cs"/>
        </a:defRPr>
      </a:lvl2pPr>
      <a:lvl3pPr marL="1948587" indent="-389716" algn="l" defTabSz="15588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983" kern="1200">
          <a:solidFill>
            <a:schemeClr val="tx1"/>
          </a:solidFill>
          <a:latin typeface="+mn-lt"/>
          <a:ea typeface="+mn-ea"/>
          <a:cs typeface="+mn-cs"/>
        </a:defRPr>
      </a:lvl3pPr>
      <a:lvl4pPr marL="2728022" indent="-389716" algn="l" defTabSz="1558870" rtl="0" eaLnBrk="1" latinLnBrk="0" hangingPunct="1">
        <a:spcBef>
          <a:spcPct val="20000"/>
        </a:spcBef>
        <a:buFont typeface="Arial" panose="020B0604020202020204" pitchFamily="34" charset="0"/>
        <a:buChar char="–"/>
        <a:defRPr sz="3613" kern="1200">
          <a:solidFill>
            <a:schemeClr val="tx1"/>
          </a:solidFill>
          <a:latin typeface="+mn-lt"/>
          <a:ea typeface="+mn-ea"/>
          <a:cs typeface="+mn-cs"/>
        </a:defRPr>
      </a:lvl4pPr>
      <a:lvl5pPr marL="3507457" indent="-389716" algn="l" defTabSz="1558870" rtl="0" eaLnBrk="1" latinLnBrk="0" hangingPunct="1">
        <a:spcBef>
          <a:spcPct val="20000"/>
        </a:spcBef>
        <a:buFont typeface="Arial" panose="020B0604020202020204" pitchFamily="34" charset="0"/>
        <a:buChar char="»"/>
        <a:defRPr sz="3613" kern="1200">
          <a:solidFill>
            <a:schemeClr val="tx1"/>
          </a:solidFill>
          <a:latin typeface="+mn-lt"/>
          <a:ea typeface="+mn-ea"/>
          <a:cs typeface="+mn-cs"/>
        </a:defRPr>
      </a:lvl5pPr>
      <a:lvl6pPr marL="4286893" indent="-389716" algn="l" defTabSz="15588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613" kern="1200">
          <a:solidFill>
            <a:schemeClr val="tx1"/>
          </a:solidFill>
          <a:latin typeface="+mn-lt"/>
          <a:ea typeface="+mn-ea"/>
          <a:cs typeface="+mn-cs"/>
        </a:defRPr>
      </a:lvl6pPr>
      <a:lvl7pPr marL="5066328" indent="-389716" algn="l" defTabSz="15588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613" kern="1200">
          <a:solidFill>
            <a:schemeClr val="tx1"/>
          </a:solidFill>
          <a:latin typeface="+mn-lt"/>
          <a:ea typeface="+mn-ea"/>
          <a:cs typeface="+mn-cs"/>
        </a:defRPr>
      </a:lvl7pPr>
      <a:lvl8pPr marL="5845764" indent="-389716" algn="l" defTabSz="15588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613" kern="1200">
          <a:solidFill>
            <a:schemeClr val="tx1"/>
          </a:solidFill>
          <a:latin typeface="+mn-lt"/>
          <a:ea typeface="+mn-ea"/>
          <a:cs typeface="+mn-cs"/>
        </a:defRPr>
      </a:lvl8pPr>
      <a:lvl9pPr marL="6625199" indent="-389716" algn="l" defTabSz="15588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6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1pPr>
      <a:lvl2pPr marL="779435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2pPr>
      <a:lvl3pPr marL="1558870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3pPr>
      <a:lvl4pPr marL="2338303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4pPr>
      <a:lvl5pPr marL="3117741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5pPr>
      <a:lvl6pPr marL="3897178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6pPr>
      <a:lvl7pPr marL="4676612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7pPr>
      <a:lvl8pPr marL="5456045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8pPr>
      <a:lvl9pPr marL="6235480" algn="l" defTabSz="1558870" rtl="0" eaLnBrk="1" latinLnBrk="0" hangingPunct="1">
        <a:defRPr sz="305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>
            <a:extLst>
              <a:ext uri="{FF2B5EF4-FFF2-40B4-BE49-F238E27FC236}">
                <a16:creationId xmlns:a16="http://schemas.microsoft.com/office/drawing/2014/main" id="{9CA385BB-0C90-4F79-A77B-141D08CC0DA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89" t="10772" r="3929" b="8648"/>
          <a:stretch/>
        </p:blipFill>
        <p:spPr>
          <a:xfrm>
            <a:off x="993542" y="891335"/>
            <a:ext cx="3506227" cy="273415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B8BA292-D6DD-4E4E-AE89-08A3EB02CA1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99" t="11209" r="3650" b="8159"/>
          <a:stretch/>
        </p:blipFill>
        <p:spPr>
          <a:xfrm>
            <a:off x="4920266" y="913274"/>
            <a:ext cx="3506228" cy="2727711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7DF68198-76E7-4018-B093-E8F48EB1BC73}"/>
              </a:ext>
            </a:extLst>
          </p:cNvPr>
          <p:cNvSpPr txBox="1"/>
          <p:nvPr/>
        </p:nvSpPr>
        <p:spPr>
          <a:xfrm>
            <a:off x="1760568" y="534450"/>
            <a:ext cx="2286985" cy="381425"/>
          </a:xfrm>
          <a:prstGeom prst="rect">
            <a:avLst/>
          </a:prstGeom>
          <a:noFill/>
        </p:spPr>
        <p:txBody>
          <a:bodyPr wrap="none" lIns="133896" tIns="66948" rIns="133896" bIns="66948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Human colon biopsy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2392D1B-28CA-4947-B971-D50E8FBD05C3}"/>
              </a:ext>
            </a:extLst>
          </p:cNvPr>
          <p:cNvSpPr txBox="1"/>
          <p:nvPr/>
        </p:nvSpPr>
        <p:spPr>
          <a:xfrm>
            <a:off x="5614196" y="534870"/>
            <a:ext cx="2490231" cy="381425"/>
          </a:xfrm>
          <a:prstGeom prst="rect">
            <a:avLst/>
          </a:prstGeom>
          <a:noFill/>
        </p:spPr>
        <p:txBody>
          <a:bodyPr wrap="square" lIns="133896" tIns="66948" rIns="133896" bIns="66948" rtlCol="0">
            <a:spAutoFit/>
          </a:bodyPr>
          <a:lstStyle/>
          <a:p>
            <a:pPr algn="ctr"/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Mouse colon tissue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7AECD9F-0A20-43F0-9612-4AEEA3684AA5}"/>
              </a:ext>
            </a:extLst>
          </p:cNvPr>
          <p:cNvSpPr txBox="1"/>
          <p:nvPr/>
        </p:nvSpPr>
        <p:spPr>
          <a:xfrm rot="16200000">
            <a:off x="-529441" y="1808613"/>
            <a:ext cx="2351566" cy="566091"/>
          </a:xfrm>
          <a:prstGeom prst="rect">
            <a:avLst/>
          </a:prstGeom>
          <a:noFill/>
        </p:spPr>
        <p:txBody>
          <a:bodyPr wrap="square" lIns="133896" tIns="66948" rIns="133896" bIns="66948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atio of bacteria detected only in depleted group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A8E4C5ED-FAEF-4EB3-A847-E528C48DB79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22" t="10598" r="2677" b="9017"/>
          <a:stretch/>
        </p:blipFill>
        <p:spPr>
          <a:xfrm>
            <a:off x="966202" y="3781340"/>
            <a:ext cx="3582427" cy="2725111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8CA1FA40-05F4-4855-B526-DE92604B39E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92" t="10892" r="3324" b="7594"/>
          <a:stretch/>
        </p:blipFill>
        <p:spPr>
          <a:xfrm>
            <a:off x="4857921" y="3788483"/>
            <a:ext cx="3582427" cy="2788383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7BEAEB25-D60C-4590-80D4-8B2A1C539518}"/>
              </a:ext>
            </a:extLst>
          </p:cNvPr>
          <p:cNvSpPr txBox="1"/>
          <p:nvPr/>
        </p:nvSpPr>
        <p:spPr>
          <a:xfrm>
            <a:off x="1214422" y="6480481"/>
            <a:ext cx="3439659" cy="381425"/>
          </a:xfrm>
          <a:prstGeom prst="rect">
            <a:avLst/>
          </a:prstGeom>
          <a:noFill/>
        </p:spPr>
        <p:txBody>
          <a:bodyPr wrap="square" lIns="133896" tIns="66948" rIns="133896" bIns="66948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bundance cutoff leve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340A50C-8DEF-4E35-A1FA-70AE9FBF1740}"/>
              </a:ext>
            </a:extLst>
          </p:cNvPr>
          <p:cNvSpPr txBox="1"/>
          <p:nvPr/>
        </p:nvSpPr>
        <p:spPr>
          <a:xfrm>
            <a:off x="5132627" y="6480481"/>
            <a:ext cx="3429000" cy="381425"/>
          </a:xfrm>
          <a:prstGeom prst="rect">
            <a:avLst/>
          </a:prstGeom>
          <a:noFill/>
        </p:spPr>
        <p:txBody>
          <a:bodyPr wrap="square" lIns="133896" tIns="66948" rIns="133896" bIns="66948" rtlCol="0">
            <a:spAutoFit/>
          </a:bodyPr>
          <a:lstStyle/>
          <a:p>
            <a:pPr algn="ctr"/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bundance cutoff leve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E8EE027-7BE6-4ED0-A2E3-DE69C72295CB}"/>
              </a:ext>
            </a:extLst>
          </p:cNvPr>
          <p:cNvSpPr txBox="1"/>
          <p:nvPr/>
        </p:nvSpPr>
        <p:spPr>
          <a:xfrm rot="16200000">
            <a:off x="-586295" y="4738076"/>
            <a:ext cx="2465274" cy="566091"/>
          </a:xfrm>
          <a:prstGeom prst="rect">
            <a:avLst/>
          </a:prstGeom>
          <a:noFill/>
        </p:spPr>
        <p:txBody>
          <a:bodyPr wrap="square" lIns="133896" tIns="66948" rIns="133896" bIns="66948" rtlCol="0">
            <a:spAutoFit/>
          </a:bodyPr>
          <a:lstStyle/>
          <a:p>
            <a:pPr algn="ctr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atio of shared bacteria in non-depleted group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FBAA2CA-2A6D-4558-88B4-CBC898C41BA7}"/>
              </a:ext>
            </a:extLst>
          </p:cNvPr>
          <p:cNvSpPr/>
          <p:nvPr/>
        </p:nvSpPr>
        <p:spPr>
          <a:xfrm>
            <a:off x="1788328" y="913274"/>
            <a:ext cx="726272" cy="2725111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849896D-A0C4-4439-8614-7405C0E95285}"/>
              </a:ext>
            </a:extLst>
          </p:cNvPr>
          <p:cNvSpPr/>
          <p:nvPr/>
        </p:nvSpPr>
        <p:spPr>
          <a:xfrm>
            <a:off x="5763524" y="915875"/>
            <a:ext cx="664575" cy="2725110"/>
          </a:xfrm>
          <a:prstGeom prst="rect">
            <a:avLst/>
          </a:prstGeom>
          <a:noFill/>
          <a:ln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75E980B-1D90-491C-A07C-AAB079EB2CF1}"/>
              </a:ext>
            </a:extLst>
          </p:cNvPr>
          <p:cNvSpPr txBox="1"/>
          <p:nvPr/>
        </p:nvSpPr>
        <p:spPr>
          <a:xfrm>
            <a:off x="0" y="663849"/>
            <a:ext cx="3378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1F7AD3C-7B4D-4F1C-BF82-76775AFF34D6}"/>
              </a:ext>
            </a:extLst>
          </p:cNvPr>
          <p:cNvSpPr txBox="1"/>
          <p:nvPr/>
        </p:nvSpPr>
        <p:spPr>
          <a:xfrm>
            <a:off x="0" y="3788484"/>
            <a:ext cx="3378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4491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88</TotalTime>
  <Words>30</Words>
  <Application>Microsoft Office PowerPoint</Application>
  <PresentationFormat>Custom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nie</dc:creator>
  <cp:lastModifiedBy>Liu Wei-Xin</cp:lastModifiedBy>
  <cp:revision>5</cp:revision>
  <dcterms:created xsi:type="dcterms:W3CDTF">2021-03-16T01:35:12Z</dcterms:created>
  <dcterms:modified xsi:type="dcterms:W3CDTF">2021-12-16T09:00:05Z</dcterms:modified>
</cp:coreProperties>
</file>